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C000"/>
    <a:srgbClr val="1A476F"/>
    <a:srgbClr val="90353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434" autoAdjust="0"/>
    <p:restoredTop sz="94660"/>
  </p:normalViewPr>
  <p:slideViewPr>
    <p:cSldViewPr snapToGrid="0">
      <p:cViewPr varScale="1">
        <p:scale>
          <a:sx n="65" d="100"/>
          <a:sy n="65" d="100"/>
        </p:scale>
        <p:origin x="2142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17FC5-0128-4901-89EF-95A3F92EC2BC}" type="datetimeFigureOut">
              <a:rPr lang="en-GB" smtClean="0"/>
              <a:t>07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0E2D5-E833-4DAC-BC77-5F4460D950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84997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17FC5-0128-4901-89EF-95A3F92EC2BC}" type="datetimeFigureOut">
              <a:rPr lang="en-GB" smtClean="0"/>
              <a:t>07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0E2D5-E833-4DAC-BC77-5F4460D950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49216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17FC5-0128-4901-89EF-95A3F92EC2BC}" type="datetimeFigureOut">
              <a:rPr lang="en-GB" smtClean="0"/>
              <a:t>07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0E2D5-E833-4DAC-BC77-5F4460D950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95262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17FC5-0128-4901-89EF-95A3F92EC2BC}" type="datetimeFigureOut">
              <a:rPr lang="en-GB" smtClean="0"/>
              <a:t>07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0E2D5-E833-4DAC-BC77-5F4460D950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71922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17FC5-0128-4901-89EF-95A3F92EC2BC}" type="datetimeFigureOut">
              <a:rPr lang="en-GB" smtClean="0"/>
              <a:t>07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0E2D5-E833-4DAC-BC77-5F4460D950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13978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17FC5-0128-4901-89EF-95A3F92EC2BC}" type="datetimeFigureOut">
              <a:rPr lang="en-GB" smtClean="0"/>
              <a:t>07/05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0E2D5-E833-4DAC-BC77-5F4460D950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12378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17FC5-0128-4901-89EF-95A3F92EC2BC}" type="datetimeFigureOut">
              <a:rPr lang="en-GB" smtClean="0"/>
              <a:t>07/05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0E2D5-E833-4DAC-BC77-5F4460D950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14222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17FC5-0128-4901-89EF-95A3F92EC2BC}" type="datetimeFigureOut">
              <a:rPr lang="en-GB" smtClean="0"/>
              <a:t>07/05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0E2D5-E833-4DAC-BC77-5F4460D950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81529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17FC5-0128-4901-89EF-95A3F92EC2BC}" type="datetimeFigureOut">
              <a:rPr lang="en-GB" smtClean="0"/>
              <a:t>07/05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0E2D5-E833-4DAC-BC77-5F4460D950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35545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17FC5-0128-4901-89EF-95A3F92EC2BC}" type="datetimeFigureOut">
              <a:rPr lang="en-GB" smtClean="0"/>
              <a:t>07/05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0E2D5-E833-4DAC-BC77-5F4460D950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76623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17FC5-0128-4901-89EF-95A3F92EC2BC}" type="datetimeFigureOut">
              <a:rPr lang="en-GB" smtClean="0"/>
              <a:t>07/05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C0E2D5-E833-4DAC-BC77-5F4460D950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35549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B17FC5-0128-4901-89EF-95A3F92EC2BC}" type="datetimeFigureOut">
              <a:rPr lang="en-GB" smtClean="0"/>
              <a:t>07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C0E2D5-E833-4DAC-BC77-5F4460D950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24107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47">
            <a:extLst>
              <a:ext uri="{FF2B5EF4-FFF2-40B4-BE49-F238E27FC236}">
                <a16:creationId xmlns:a16="http://schemas.microsoft.com/office/drawing/2014/main" id="{66777E15-19EF-4E2B-8BED-0A9C452E69C7}"/>
              </a:ext>
            </a:extLst>
          </p:cNvPr>
          <p:cNvSpPr txBox="1"/>
          <p:nvPr/>
        </p:nvSpPr>
        <p:spPr>
          <a:xfrm>
            <a:off x="203448" y="102792"/>
            <a:ext cx="198730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</a:t>
            </a: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E574C01E-C50D-F01B-52AB-12F0BB5E1C78}"/>
              </a:ext>
            </a:extLst>
          </p:cNvPr>
          <p:cNvGrpSpPr/>
          <p:nvPr/>
        </p:nvGrpSpPr>
        <p:grpSpPr>
          <a:xfrm>
            <a:off x="1389567" y="762000"/>
            <a:ext cx="4622288" cy="2467809"/>
            <a:chOff x="221175" y="591751"/>
            <a:chExt cx="4401623" cy="2467809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77EEC7F5-E581-A7C2-8508-FBE8E8C97B40}"/>
                </a:ext>
              </a:extLst>
            </p:cNvPr>
            <p:cNvSpPr txBox="1"/>
            <p:nvPr/>
          </p:nvSpPr>
          <p:spPr>
            <a:xfrm>
              <a:off x="221175" y="591751"/>
              <a:ext cx="2475914" cy="246221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78 NSCLC adenocarcinoma patients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C6A5D04-2849-E07C-D9FF-036877B9D3ED}"/>
                </a:ext>
              </a:extLst>
            </p:cNvPr>
            <p:cNvSpPr txBox="1"/>
            <p:nvPr/>
          </p:nvSpPr>
          <p:spPr>
            <a:xfrm>
              <a:off x="221175" y="1211650"/>
              <a:ext cx="2475914" cy="246221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66 patient cases with clinical data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432627B-59AE-6F1C-1DAD-F0DBEE549830}"/>
                </a:ext>
              </a:extLst>
            </p:cNvPr>
            <p:cNvSpPr txBox="1"/>
            <p:nvPr/>
          </p:nvSpPr>
          <p:spPr>
            <a:xfrm>
              <a:off x="2765865" y="915542"/>
              <a:ext cx="1792054" cy="246221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2 missing clinical data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1C5C6A97-BFA1-21E9-C824-C2A1A68C27A2}"/>
                </a:ext>
              </a:extLst>
            </p:cNvPr>
            <p:cNvSpPr txBox="1"/>
            <p:nvPr/>
          </p:nvSpPr>
          <p:spPr>
            <a:xfrm>
              <a:off x="221175" y="1847562"/>
              <a:ext cx="2475914" cy="400110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57 patient cases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analysed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for </a:t>
              </a:r>
            </a:p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151 staining intensity*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2857CE5F-C2EB-EB44-0F50-F312F0112BE1}"/>
                </a:ext>
              </a:extLst>
            </p:cNvPr>
            <p:cNvSpPr txBox="1"/>
            <p:nvPr/>
          </p:nvSpPr>
          <p:spPr>
            <a:xfrm>
              <a:off x="2765865" y="1466563"/>
              <a:ext cx="1856933" cy="400110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4 unsuitable section or insufficient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tumour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area for IHC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3D5C55C1-D983-6EA3-FAC7-A1A9BAD6567D}"/>
                </a:ext>
              </a:extLst>
            </p:cNvPr>
            <p:cNvSpPr txBox="1"/>
            <p:nvPr/>
          </p:nvSpPr>
          <p:spPr>
            <a:xfrm>
              <a:off x="221175" y="2659450"/>
              <a:ext cx="2475914" cy="400110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48 patient cases 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analysed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for CD151 intensity and EGFR mutation status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C1BB7AF4-8F33-0441-3D8D-4B3A7C52D5FC}"/>
                </a:ext>
              </a:extLst>
            </p:cNvPr>
            <p:cNvSpPr txBox="1"/>
            <p:nvPr/>
          </p:nvSpPr>
          <p:spPr>
            <a:xfrm>
              <a:off x="2765865" y="2278450"/>
              <a:ext cx="1792054" cy="400110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9 excluded because EGFR mutation status unknown</a:t>
              </a:r>
            </a:p>
          </p:txBody>
        </p:sp>
        <p:cxnSp>
          <p:nvCxnSpPr>
            <p:cNvPr id="45" name="Straight Arrow Connector 44">
              <a:extLst>
                <a:ext uri="{FF2B5EF4-FFF2-40B4-BE49-F238E27FC236}">
                  <a16:creationId xmlns:a16="http://schemas.microsoft.com/office/drawing/2014/main" id="{56B1C36B-BD47-4216-1E60-ECA87B45B09F}"/>
                </a:ext>
              </a:extLst>
            </p:cNvPr>
            <p:cNvCxnSpPr/>
            <p:nvPr/>
          </p:nvCxnSpPr>
          <p:spPr>
            <a:xfrm>
              <a:off x="1459132" y="848272"/>
              <a:ext cx="0" cy="363378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Arrow Connector 45">
              <a:extLst>
                <a:ext uri="{FF2B5EF4-FFF2-40B4-BE49-F238E27FC236}">
                  <a16:creationId xmlns:a16="http://schemas.microsoft.com/office/drawing/2014/main" id="{DDF65618-6FCB-575B-67BA-3C6EE5BD636B}"/>
                </a:ext>
              </a:extLst>
            </p:cNvPr>
            <p:cNvCxnSpPr/>
            <p:nvPr/>
          </p:nvCxnSpPr>
          <p:spPr>
            <a:xfrm flipV="1">
              <a:off x="1459132" y="1038652"/>
              <a:ext cx="1303981" cy="1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Arrow Connector 48">
              <a:extLst>
                <a:ext uri="{FF2B5EF4-FFF2-40B4-BE49-F238E27FC236}">
                  <a16:creationId xmlns:a16="http://schemas.microsoft.com/office/drawing/2014/main" id="{1B3CA32A-FD07-A4C1-CF1D-CA1C28B9B8AD}"/>
                </a:ext>
              </a:extLst>
            </p:cNvPr>
            <p:cNvCxnSpPr/>
            <p:nvPr/>
          </p:nvCxnSpPr>
          <p:spPr>
            <a:xfrm>
              <a:off x="1459132" y="1484185"/>
              <a:ext cx="0" cy="363378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Arrow Connector 49">
              <a:extLst>
                <a:ext uri="{FF2B5EF4-FFF2-40B4-BE49-F238E27FC236}">
                  <a16:creationId xmlns:a16="http://schemas.microsoft.com/office/drawing/2014/main" id="{BFC853ED-5B0D-E335-BA64-0BC7F910798E}"/>
                </a:ext>
              </a:extLst>
            </p:cNvPr>
            <p:cNvCxnSpPr/>
            <p:nvPr/>
          </p:nvCxnSpPr>
          <p:spPr>
            <a:xfrm flipV="1">
              <a:off x="1459132" y="1695162"/>
              <a:ext cx="1303981" cy="1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Arrow Connector 50">
              <a:extLst>
                <a:ext uri="{FF2B5EF4-FFF2-40B4-BE49-F238E27FC236}">
                  <a16:creationId xmlns:a16="http://schemas.microsoft.com/office/drawing/2014/main" id="{CA4D4808-1364-0C52-66E9-C171F27210D4}"/>
                </a:ext>
              </a:extLst>
            </p:cNvPr>
            <p:cNvCxnSpPr/>
            <p:nvPr/>
          </p:nvCxnSpPr>
          <p:spPr>
            <a:xfrm>
              <a:off x="1459132" y="2296073"/>
              <a:ext cx="0" cy="363378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Arrow Connector 51">
              <a:extLst>
                <a:ext uri="{FF2B5EF4-FFF2-40B4-BE49-F238E27FC236}">
                  <a16:creationId xmlns:a16="http://schemas.microsoft.com/office/drawing/2014/main" id="{DA235CF9-5C23-42A7-E22F-277E4E304720}"/>
                </a:ext>
              </a:extLst>
            </p:cNvPr>
            <p:cNvCxnSpPr/>
            <p:nvPr/>
          </p:nvCxnSpPr>
          <p:spPr>
            <a:xfrm flipV="1">
              <a:off x="1459132" y="2507050"/>
              <a:ext cx="1303981" cy="1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9166788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02</TotalTime>
  <Words>54</Words>
  <Application>Microsoft Office PowerPoint</Application>
  <PresentationFormat>A4 Paper (210x297 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National University of Singapor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_</dc:creator>
  <cp:lastModifiedBy>Thai Tran</cp:lastModifiedBy>
  <cp:revision>101</cp:revision>
  <dcterms:created xsi:type="dcterms:W3CDTF">2019-04-24T04:33:15Z</dcterms:created>
  <dcterms:modified xsi:type="dcterms:W3CDTF">2024-05-06T16:06:22Z</dcterms:modified>
</cp:coreProperties>
</file>